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6858000" cy="9906000" type="A4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1" d="100"/>
          <a:sy n="91" d="100"/>
        </p:scale>
        <p:origin x="-1218" y="238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92B64C-92A6-4443-B744-C4E22BEFE740}" type="datetimeFigureOut">
              <a:rPr lang="el-GR" smtClean="0"/>
              <a:t>16/6/2015</a:t>
            </a:fld>
            <a:endParaRPr lang="el-G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0FB836-0BA7-452A-9E59-68529ED7D3CE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2969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16/6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16/6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16/6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16/6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16/6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16/6/201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16/6/2015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16/6/2015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16/6/2015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16/6/201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16/6/201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81947D-1B65-4F10-B07A-85B11A127EFF}" type="datetimeFigureOut">
              <a:rPr lang="el-GR" smtClean="0"/>
              <a:t>16/6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287" y="272480"/>
            <a:ext cx="6247426" cy="798078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939181" y="8483133"/>
            <a:ext cx="49145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. 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5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erpenoi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backbon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biosynthesis pathway as retrieved from KEGG databas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enzymes 1-deoxy-D-xylulose 5-phosphate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reductoisomeras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E.C. number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1.1.267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-(cytidine 5'-diphospho)-2-C-methyl-D-erythritol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inas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(E.C. number 2.7.1.148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nd 4-hydroxy-3-methylbut-2-en-1-yl diphosphate synthase (E.C. number 1.17.7.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 are highlighted in green, red and blue respectively.</a:t>
            </a:r>
            <a:endParaRPr lang="el-G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64711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5.PPTX</DocumentId>
    <DocumentType xmlns="370fed10-a368-469c-a864-2e77a9536334">Presentation</DocumentType>
    <TitleName xmlns="370fed10-a368-469c-a864-2e77a9536334">Presentation 5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27BD7212-00EC-47B2-9F7C-99DA54CA39C9}"/>
</file>

<file path=customXml/itemProps2.xml><?xml version="1.0" encoding="utf-8"?>
<ds:datastoreItem xmlns:ds="http://schemas.openxmlformats.org/officeDocument/2006/customXml" ds:itemID="{B1136C9D-282A-4BC0-8353-ACB2DDE36B97}"/>
</file>

<file path=customXml/itemProps3.xml><?xml version="1.0" encoding="utf-8"?>
<ds:datastoreItem xmlns:ds="http://schemas.openxmlformats.org/officeDocument/2006/customXml" ds:itemID="{BCC4C0EF-405D-4E54-8D03-766AAA694ECF}"/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61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pasia</dc:creator>
  <cp:lastModifiedBy>Koudounelos</cp:lastModifiedBy>
  <cp:revision>17</cp:revision>
  <dcterms:created xsi:type="dcterms:W3CDTF">2013-04-30T09:15:21Z</dcterms:created>
  <dcterms:modified xsi:type="dcterms:W3CDTF">2015-06-16T17:08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725EE384B7A58499F7B801D4EF867A9</vt:lpwstr>
  </property>
</Properties>
</file>